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4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46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C0DCA6-5BBE-E6EF-0234-A6DBAB04AC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7612240-CA12-DC8E-6F00-353D4319E2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C1B9F1-AA32-622E-4D14-EEEA0A905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11A7615-BFF3-4B4B-6029-2BAACD4A3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392990-84EA-9104-E83D-E4D9E7B0C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8138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186774A-955C-E232-70F0-EA0388C8B6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64A8999-85AC-7D64-8050-C0B3683362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F3BC32-BFA6-AB84-131F-52AC12D74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AA158F7-88A8-B112-7DAD-368ABAD17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1D8EE3F-A921-8E07-BEA3-AB30E0487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8190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9C1501B-65BC-ACE9-BE23-979148D09CC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1427D67-AD57-554E-0CA0-7C767F43D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6FAADC2-A96F-940E-D69D-59BAC5CCDA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1BD89F7-C3F3-3B2E-D1EC-B6AE227EC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046E892-DCE6-18FA-3A7D-319200260D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3175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4CA12DC-DDAF-4A9F-FD5B-3D0686AACE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F118153-7FC4-2D78-53D8-5DF37AE575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AC6468-EF4F-3E30-FA38-74E935D88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7681D21-AEDA-7CAE-4488-54D88154EF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29D9C03-ED77-0C89-7191-FD6615943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1890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8681CF1-FCEF-1A88-8B9D-DC9A9C02CC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1D03585-8700-BF88-4DC7-AFB2F7186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CC94DE1-FE3B-087B-3976-33178E4E6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5A8B938-5431-35DA-5A80-0D426DF86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E30EB07-805B-064C-C5B4-1502AF313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75001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D70C7FF-F0A6-AA69-C967-500404421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E9916FF-58C6-B89F-A015-93FDF28442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7870DAD-3FA4-0F28-B6AC-3348D533B6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F5365E7-4672-D4BA-B524-26A7C9F4E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C28E2A5-E6E5-DC91-129B-4A0348B44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5B1EC01-BBA8-E4C8-7C6B-09B65E46F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53708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BF1E24B-598E-0F26-E56A-99FD68FE2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1EF641B-32A1-167A-85B8-F8F3F81793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D052273-6902-6C72-7963-9DC415415C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D024866-0E1C-9D1F-786D-A86D35AACE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9273534-0530-B373-DE8B-DC88D9285D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E254209-ACE3-7E53-EA55-55FDFE416A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F9FD13A-C974-B8D8-2471-C32F0CF62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9A24113-6BD7-0D2D-EBE4-651BE60B9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3233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319FE4-4CF3-BA7D-D150-B2B9945035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DD80D76-FDA4-9719-F978-D8DF2D8DB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063C0883-696A-3F4C-8877-BA7637EF8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366C8DC-8D46-D470-1D01-7626E27EBB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87223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EE4982C-51A9-A58A-9491-5128770A8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32D2C37-8F9C-07F7-3959-4DB13B496A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8F42125-D175-DE3C-D46D-A6530A65BB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71660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539F905-AFD1-74B9-DBCA-7C34B6B0B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36E7BD1-6BA6-8DF8-B2F6-77B9E03618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2EE0AFF-7E1B-2C53-315B-AD251DD2E3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7A19188-825C-0B48-74AC-E1446ACE4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AB422CB-4D8F-A214-D110-1A290D62D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08E2BC2-BEEA-7162-2B2B-F40F19A94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1521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B23BA8-C0CF-95D8-E4E3-6229103582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C6B238A-8750-2553-7178-C8E6F31A8E3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2C0DAB3-A3A6-1859-DCF5-0742BE5735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850312B-3207-4E30-A283-424B464B1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1C676AD-67FF-7987-3BC3-A5340BE78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BB0A6BE-C8DB-3179-8220-2089D401E8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8855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2C119269-2963-F532-8B89-0D88A8E39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CFD8D7-9245-D3AF-42EF-03F327878D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2C3AF8-6241-D13E-DD5E-A10701D32A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5B2BB-C8CC-4177-A4F6-5BAF09283787}" type="datetimeFigureOut">
              <a:rPr lang="it-IT" smtClean="0"/>
              <a:t>13/04/20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49BCD95-5147-E921-AB91-95C787BF89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CDA536-4420-EE48-FAEE-D602F75EA7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92B90B-EA59-442C-B0B3-1CA735863CE4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8502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magine 16">
            <a:extLst>
              <a:ext uri="{FF2B5EF4-FFF2-40B4-BE49-F238E27FC236}">
                <a16:creationId xmlns:a16="http://schemas.microsoft.com/office/drawing/2014/main" id="{096B31AE-3A8F-46DD-757D-B8CF44B95C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392" r="22249" b="25145"/>
          <a:stretch/>
        </p:blipFill>
        <p:spPr>
          <a:xfrm>
            <a:off x="426076" y="1384916"/>
            <a:ext cx="5332156" cy="4352363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id="{584CAA30-D921-4C81-4DF4-1305686DEC14}"/>
              </a:ext>
            </a:extLst>
          </p:cNvPr>
          <p:cNvGrpSpPr/>
          <p:nvPr/>
        </p:nvGrpSpPr>
        <p:grpSpPr>
          <a:xfrm>
            <a:off x="1172134" y="380674"/>
            <a:ext cx="2490485" cy="1112009"/>
            <a:chOff x="1207020" y="480746"/>
            <a:chExt cx="1463088" cy="735884"/>
          </a:xfrm>
        </p:grpSpPr>
        <p:sp>
          <p:nvSpPr>
            <p:cNvPr id="2" name="CasellaDiTesto 35">
              <a:extLst>
                <a:ext uri="{FF2B5EF4-FFF2-40B4-BE49-F238E27FC236}">
                  <a16:creationId xmlns:a16="http://schemas.microsoft.com/office/drawing/2014/main" id="{41C1C37B-3051-FAF9-1AFA-BA42A026B600}"/>
                </a:ext>
              </a:extLst>
            </p:cNvPr>
            <p:cNvSpPr txBox="1"/>
            <p:nvPr/>
          </p:nvSpPr>
          <p:spPr>
            <a:xfrm>
              <a:off x="1233920" y="480746"/>
              <a:ext cx="1382131" cy="183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TID-LST8</a:t>
              </a:r>
            </a:p>
          </p:txBody>
        </p:sp>
        <p:sp>
          <p:nvSpPr>
            <p:cNvPr id="3" name="CasellaDiTesto 36">
              <a:extLst>
                <a:ext uri="{FF2B5EF4-FFF2-40B4-BE49-F238E27FC236}">
                  <a16:creationId xmlns:a16="http://schemas.microsoft.com/office/drawing/2014/main" id="{A39B8A86-DF4D-653C-090B-3366245A12DF}"/>
                </a:ext>
              </a:extLst>
            </p:cNvPr>
            <p:cNvSpPr txBox="1"/>
            <p:nvPr/>
          </p:nvSpPr>
          <p:spPr>
            <a:xfrm>
              <a:off x="1229064" y="741005"/>
              <a:ext cx="930487" cy="162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-221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4" name="CasellaDiTesto 37">
              <a:extLst>
                <a:ext uri="{FF2B5EF4-FFF2-40B4-BE49-F238E27FC236}">
                  <a16:creationId xmlns:a16="http://schemas.microsoft.com/office/drawing/2014/main" id="{EFBA8071-2126-60BC-0006-E97DCC4C4439}"/>
                </a:ext>
              </a:extLst>
            </p:cNvPr>
            <p:cNvSpPr txBox="1"/>
            <p:nvPr/>
          </p:nvSpPr>
          <p:spPr>
            <a:xfrm>
              <a:off x="1739621" y="699790"/>
              <a:ext cx="930487" cy="264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SSU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7-79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</a:p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5-221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5" name="CasellaDiTesto 38">
              <a:extLst>
                <a:ext uri="{FF2B5EF4-FFF2-40B4-BE49-F238E27FC236}">
                  <a16:creationId xmlns:a16="http://schemas.microsoft.com/office/drawing/2014/main" id="{7FAF9C1E-DBD2-4F04-0E70-C0B7FE853F9B}"/>
                </a:ext>
              </a:extLst>
            </p:cNvPr>
            <p:cNvSpPr txBox="1"/>
            <p:nvPr/>
          </p:nvSpPr>
          <p:spPr>
            <a:xfrm>
              <a:off x="1207020" y="1048598"/>
              <a:ext cx="456237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9" name="CasellaDiTesto 39">
              <a:extLst>
                <a:ext uri="{FF2B5EF4-FFF2-40B4-BE49-F238E27FC236}">
                  <a16:creationId xmlns:a16="http://schemas.microsoft.com/office/drawing/2014/main" id="{AF363223-5B9F-2423-0ACB-2A21DB2D7534}"/>
                </a:ext>
              </a:extLst>
            </p:cNvPr>
            <p:cNvSpPr txBox="1"/>
            <p:nvPr/>
          </p:nvSpPr>
          <p:spPr>
            <a:xfrm>
              <a:off x="1877415" y="1048598"/>
              <a:ext cx="452078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6" name="CasellaDiTesto 40">
              <a:extLst>
                <a:ext uri="{FF2B5EF4-FFF2-40B4-BE49-F238E27FC236}">
                  <a16:creationId xmlns:a16="http://schemas.microsoft.com/office/drawing/2014/main" id="{8B176B21-FD45-BB5D-477E-6670881B692B}"/>
                </a:ext>
              </a:extLst>
            </p:cNvPr>
            <p:cNvSpPr txBox="1"/>
            <p:nvPr/>
          </p:nvSpPr>
          <p:spPr>
            <a:xfrm>
              <a:off x="1561605" y="1048598"/>
              <a:ext cx="417462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AZD</a:t>
              </a:r>
            </a:p>
          </p:txBody>
        </p:sp>
        <p:sp>
          <p:nvSpPr>
            <p:cNvPr id="20" name="CasellaDiTesto 41">
              <a:extLst>
                <a:ext uri="{FF2B5EF4-FFF2-40B4-BE49-F238E27FC236}">
                  <a16:creationId xmlns:a16="http://schemas.microsoft.com/office/drawing/2014/main" id="{B42511F7-BC25-7371-8CDB-79064622AD0A}"/>
                </a:ext>
              </a:extLst>
            </p:cNvPr>
            <p:cNvSpPr txBox="1"/>
            <p:nvPr/>
          </p:nvSpPr>
          <p:spPr>
            <a:xfrm>
              <a:off x="2227841" y="1048598"/>
              <a:ext cx="417461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AZD</a:t>
              </a:r>
            </a:p>
          </p:txBody>
        </p:sp>
      </p:grpSp>
      <p:pic>
        <p:nvPicPr>
          <p:cNvPr id="24" name="Picture 23">
            <a:extLst>
              <a:ext uri="{FF2B5EF4-FFF2-40B4-BE49-F238E27FC236}">
                <a16:creationId xmlns:a16="http://schemas.microsoft.com/office/drawing/2014/main" id="{8BB60EC1-4566-E68A-7F6E-3FF22C3CA8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5995515" y="1323206"/>
            <a:ext cx="5404339" cy="4475782"/>
          </a:xfrm>
          <a:prstGeom prst="rect">
            <a:avLst/>
          </a:prstGeom>
        </p:spPr>
      </p:pic>
      <p:grpSp>
        <p:nvGrpSpPr>
          <p:cNvPr id="25" name="Group 24">
            <a:extLst>
              <a:ext uri="{FF2B5EF4-FFF2-40B4-BE49-F238E27FC236}">
                <a16:creationId xmlns:a16="http://schemas.microsoft.com/office/drawing/2014/main" id="{CCBEB9CE-C846-ED75-BC5D-D218CE299BEA}"/>
              </a:ext>
            </a:extLst>
          </p:cNvPr>
          <p:cNvGrpSpPr/>
          <p:nvPr/>
        </p:nvGrpSpPr>
        <p:grpSpPr>
          <a:xfrm>
            <a:off x="6627307" y="341062"/>
            <a:ext cx="2490485" cy="1112009"/>
            <a:chOff x="1207020" y="480746"/>
            <a:chExt cx="1463088" cy="735884"/>
          </a:xfrm>
        </p:grpSpPr>
        <p:sp>
          <p:nvSpPr>
            <p:cNvPr id="26" name="CasellaDiTesto 35">
              <a:extLst>
                <a:ext uri="{FF2B5EF4-FFF2-40B4-BE49-F238E27FC236}">
                  <a16:creationId xmlns:a16="http://schemas.microsoft.com/office/drawing/2014/main" id="{B3EE8F50-54D9-05F6-4090-47634621FC15}"/>
                </a:ext>
              </a:extLst>
            </p:cNvPr>
            <p:cNvSpPr txBox="1"/>
            <p:nvPr/>
          </p:nvSpPr>
          <p:spPr>
            <a:xfrm>
              <a:off x="1233920" y="480746"/>
              <a:ext cx="1382131" cy="1833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anose="020B0604020202020204" pitchFamily="34" charset="0"/>
                </a:rPr>
                <a:t>TID-LST8</a:t>
              </a:r>
            </a:p>
          </p:txBody>
        </p:sp>
        <p:sp>
          <p:nvSpPr>
            <p:cNvPr id="27" name="CasellaDiTesto 36">
              <a:extLst>
                <a:ext uri="{FF2B5EF4-FFF2-40B4-BE49-F238E27FC236}">
                  <a16:creationId xmlns:a16="http://schemas.microsoft.com/office/drawing/2014/main" id="{80130619-8CA5-9B4B-E84D-8B404D378635}"/>
                </a:ext>
              </a:extLst>
            </p:cNvPr>
            <p:cNvSpPr txBox="1"/>
            <p:nvPr/>
          </p:nvSpPr>
          <p:spPr>
            <a:xfrm>
              <a:off x="1229064" y="741005"/>
              <a:ext cx="930487" cy="1629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9-221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28" name="CasellaDiTesto 37">
              <a:extLst>
                <a:ext uri="{FF2B5EF4-FFF2-40B4-BE49-F238E27FC236}">
                  <a16:creationId xmlns:a16="http://schemas.microsoft.com/office/drawing/2014/main" id="{FB1AEA6B-4AEE-F696-4C8B-0CA832FBED14}"/>
                </a:ext>
              </a:extLst>
            </p:cNvPr>
            <p:cNvSpPr txBox="1"/>
            <p:nvPr/>
          </p:nvSpPr>
          <p:spPr>
            <a:xfrm>
              <a:off x="1739621" y="699790"/>
              <a:ext cx="930487" cy="264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SSU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7-79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</a:p>
            <a:p>
              <a:pPr algn="ctr"/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RSH3</a:t>
              </a:r>
              <a:r>
                <a:rPr lang="it-IT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65-221</a:t>
              </a:r>
              <a:r>
                <a:rPr lang="it-IT" sz="1000" dirty="0">
                  <a:latin typeface="Arial" panose="020B0604020202020204" pitchFamily="34" charset="0"/>
                  <a:cs typeface="Arial" panose="020B0604020202020204" pitchFamily="34" charset="0"/>
                </a:rPr>
                <a:t>-GFP</a:t>
              </a:r>
            </a:p>
          </p:txBody>
        </p:sp>
        <p:sp>
          <p:nvSpPr>
            <p:cNvPr id="29" name="CasellaDiTesto 38">
              <a:extLst>
                <a:ext uri="{FF2B5EF4-FFF2-40B4-BE49-F238E27FC236}">
                  <a16:creationId xmlns:a16="http://schemas.microsoft.com/office/drawing/2014/main" id="{98B93089-DC84-976D-AAE6-96DC61627B03}"/>
                </a:ext>
              </a:extLst>
            </p:cNvPr>
            <p:cNvSpPr txBox="1"/>
            <p:nvPr/>
          </p:nvSpPr>
          <p:spPr>
            <a:xfrm>
              <a:off x="1207020" y="1048598"/>
              <a:ext cx="456237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30" name="CasellaDiTesto 39">
              <a:extLst>
                <a:ext uri="{FF2B5EF4-FFF2-40B4-BE49-F238E27FC236}">
                  <a16:creationId xmlns:a16="http://schemas.microsoft.com/office/drawing/2014/main" id="{2BEFF8D9-459C-F3B6-70C4-913C150B8BE5}"/>
                </a:ext>
              </a:extLst>
            </p:cNvPr>
            <p:cNvSpPr txBox="1"/>
            <p:nvPr/>
          </p:nvSpPr>
          <p:spPr>
            <a:xfrm>
              <a:off x="1877415" y="1048598"/>
              <a:ext cx="452078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31" name="CasellaDiTesto 40">
              <a:extLst>
                <a:ext uri="{FF2B5EF4-FFF2-40B4-BE49-F238E27FC236}">
                  <a16:creationId xmlns:a16="http://schemas.microsoft.com/office/drawing/2014/main" id="{E8F19B23-EBED-EED5-860A-59B9C83FCCF9}"/>
                </a:ext>
              </a:extLst>
            </p:cNvPr>
            <p:cNvSpPr txBox="1"/>
            <p:nvPr/>
          </p:nvSpPr>
          <p:spPr>
            <a:xfrm>
              <a:off x="1561605" y="1048598"/>
              <a:ext cx="417462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AZD</a:t>
              </a:r>
            </a:p>
          </p:txBody>
        </p:sp>
        <p:sp>
          <p:nvSpPr>
            <p:cNvPr id="32" name="CasellaDiTesto 41">
              <a:extLst>
                <a:ext uri="{FF2B5EF4-FFF2-40B4-BE49-F238E27FC236}">
                  <a16:creationId xmlns:a16="http://schemas.microsoft.com/office/drawing/2014/main" id="{A5C1F764-E32B-6000-9380-767A30C94E77}"/>
                </a:ext>
              </a:extLst>
            </p:cNvPr>
            <p:cNvSpPr txBox="1"/>
            <p:nvPr/>
          </p:nvSpPr>
          <p:spPr>
            <a:xfrm>
              <a:off x="2227841" y="1048598"/>
              <a:ext cx="417461" cy="1680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>
                  <a:latin typeface="Arial" panose="020B0604020202020204" pitchFamily="34" charset="0"/>
                  <a:cs typeface="Arial" panose="020B0604020202020204" pitchFamily="34" charset="0"/>
                </a:rPr>
                <a:t>AZD</a:t>
              </a:r>
            </a:p>
          </p:txBody>
        </p:sp>
      </p:grpSp>
      <p:sp>
        <p:nvSpPr>
          <p:cNvPr id="33" name="CasellaDiTesto 7">
            <a:extLst>
              <a:ext uri="{FF2B5EF4-FFF2-40B4-BE49-F238E27FC236}">
                <a16:creationId xmlns:a16="http://schemas.microsoft.com/office/drawing/2014/main" id="{CCC66B21-D975-9F54-1708-23AFA46EB7A8}"/>
              </a:ext>
            </a:extLst>
          </p:cNvPr>
          <p:cNvSpPr txBox="1"/>
          <p:nvPr/>
        </p:nvSpPr>
        <p:spPr>
          <a:xfrm>
            <a:off x="2793544" y="6007824"/>
            <a:ext cx="5677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Biotin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asellaDiTesto 7">
            <a:extLst>
              <a:ext uri="{FF2B5EF4-FFF2-40B4-BE49-F238E27FC236}">
                <a16:creationId xmlns:a16="http://schemas.microsoft.com/office/drawing/2014/main" id="{9B445F4F-A6AE-AEEF-6790-A753913AFD58}"/>
              </a:ext>
            </a:extLst>
          </p:cNvPr>
          <p:cNvSpPr txBox="1"/>
          <p:nvPr/>
        </p:nvSpPr>
        <p:spPr>
          <a:xfrm>
            <a:off x="8413792" y="6007823"/>
            <a:ext cx="8178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anose="020B0604020202020204" pitchFamily="34" charset="0"/>
                <a:cs typeface="Arial" panose="020B0604020202020204" pitchFamily="34" charset="0"/>
              </a:rPr>
              <a:t>Anti-GFP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2ABF7FBB-1882-2D59-4556-072D11D6D6F3}"/>
              </a:ext>
            </a:extLst>
          </p:cNvPr>
          <p:cNvSpPr/>
          <p:nvPr/>
        </p:nvSpPr>
        <p:spPr>
          <a:xfrm>
            <a:off x="1061419" y="3561097"/>
            <a:ext cx="2264586" cy="703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072E70E7-D0BF-E739-ECA8-FBCAB519242E}"/>
              </a:ext>
            </a:extLst>
          </p:cNvPr>
          <p:cNvSpPr/>
          <p:nvPr/>
        </p:nvSpPr>
        <p:spPr>
          <a:xfrm>
            <a:off x="6606586" y="3651981"/>
            <a:ext cx="2264586" cy="7033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00517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</dc:creator>
  <cp:lastModifiedBy>FIELD Benjamin</cp:lastModifiedBy>
  <cp:revision>2</cp:revision>
  <dcterms:created xsi:type="dcterms:W3CDTF">2023-03-27T10:55:32Z</dcterms:created>
  <dcterms:modified xsi:type="dcterms:W3CDTF">2023-04-13T14:25:51Z</dcterms:modified>
</cp:coreProperties>
</file>